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6"/>
  </p:notesMasterIdLst>
  <p:handoutMasterIdLst>
    <p:handoutMasterId r:id="rId7"/>
  </p:handoutMasterIdLst>
  <p:sldIdLst>
    <p:sldId id="256" r:id="rId2"/>
    <p:sldId id="258" r:id="rId3"/>
    <p:sldId id="259" r:id="rId4"/>
    <p:sldId id="260" r:id="rId5"/>
  </p:sldIdLst>
  <p:sldSz cx="30279975" cy="428085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9D9E"/>
    <a:srgbClr val="2F5597"/>
    <a:srgbClr val="C80000"/>
    <a:srgbClr val="8E0000"/>
    <a:srgbClr val="B103E1"/>
    <a:srgbClr val="9999DB"/>
    <a:srgbClr val="0AB9DC"/>
    <a:srgbClr val="E8A9ED"/>
    <a:srgbClr val="FDE2FE"/>
    <a:srgbClr val="F8AAF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394" autoAdjust="0"/>
    <p:restoredTop sz="96395" autoAdjust="0"/>
  </p:normalViewPr>
  <p:slideViewPr>
    <p:cSldViewPr snapToGrid="0">
      <p:cViewPr>
        <p:scale>
          <a:sx n="33" d="100"/>
          <a:sy n="33" d="100"/>
        </p:scale>
        <p:origin x="2244" y="-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 varScale="1">
        <p:scale>
          <a:sx n="88" d="100"/>
          <a:sy n="88" d="100"/>
        </p:scale>
        <p:origin x="3822" y="60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0905619-D10A-4A02-976D-DAA26DFBF04C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136AC33-B7C7-4E6D-8B63-564FDB3F57C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076842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F623E4-42F8-4879-9833-9E003F8692BF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6B3722-13A5-4258-B1F0-BF6CFBC2FE2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03955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1pPr>
    <a:lvl2pPr marL="919109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2pPr>
    <a:lvl3pPr marL="1838218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3pPr>
    <a:lvl4pPr marL="2757327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4pPr>
    <a:lvl5pPr marL="3676437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5pPr>
    <a:lvl6pPr marL="4595546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6pPr>
    <a:lvl7pPr marL="5514655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7pPr>
    <a:lvl8pPr marL="6433764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8pPr>
    <a:lvl9pPr marL="7352873" algn="l" defTabSz="1838218" rtl="0" eaLnBrk="1" latinLnBrk="0" hangingPunct="1">
      <a:defRPr sz="2412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B6B3722-13A5-4258-B1F0-BF6CFBC2FE21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57210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998" y="7005935"/>
            <a:ext cx="25737979" cy="14903709"/>
          </a:xfrm>
        </p:spPr>
        <p:txBody>
          <a:bodyPr anchor="b"/>
          <a:lstStyle>
            <a:lvl1pPr algn="ctr">
              <a:defRPr sz="1986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4997" y="22484388"/>
            <a:ext cx="22709981" cy="10335481"/>
          </a:xfrm>
        </p:spPr>
        <p:txBody>
          <a:bodyPr/>
          <a:lstStyle>
            <a:lvl1pPr marL="0" indent="0" algn="ctr">
              <a:buNone/>
              <a:defRPr sz="7948"/>
            </a:lvl1pPr>
            <a:lvl2pPr marL="1514018" indent="0" algn="ctr">
              <a:buNone/>
              <a:defRPr sz="6623"/>
            </a:lvl2pPr>
            <a:lvl3pPr marL="3028036" indent="0" algn="ctr">
              <a:buNone/>
              <a:defRPr sz="5961"/>
            </a:lvl3pPr>
            <a:lvl4pPr marL="4542053" indent="0" algn="ctr">
              <a:buNone/>
              <a:defRPr sz="5298"/>
            </a:lvl4pPr>
            <a:lvl5pPr marL="6056071" indent="0" algn="ctr">
              <a:buNone/>
              <a:defRPr sz="5298"/>
            </a:lvl5pPr>
            <a:lvl6pPr marL="7570089" indent="0" algn="ctr">
              <a:buNone/>
              <a:defRPr sz="5298"/>
            </a:lvl6pPr>
            <a:lvl7pPr marL="9084107" indent="0" algn="ctr">
              <a:buNone/>
              <a:defRPr sz="5298"/>
            </a:lvl7pPr>
            <a:lvl8pPr marL="10598125" indent="0" algn="ctr">
              <a:buNone/>
              <a:defRPr sz="5298"/>
            </a:lvl8pPr>
            <a:lvl9pPr marL="12112142" indent="0" algn="ctr">
              <a:buNone/>
              <a:defRPr sz="5298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5414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76628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9109" y="2279158"/>
            <a:ext cx="6529120" cy="36278246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1750" y="2279158"/>
            <a:ext cx="19208859" cy="36278246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4322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95300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979" y="10672416"/>
            <a:ext cx="26116478" cy="17807154"/>
          </a:xfrm>
        </p:spPr>
        <p:txBody>
          <a:bodyPr anchor="b"/>
          <a:lstStyle>
            <a:lvl1pPr>
              <a:defRPr sz="1986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979" y="28648032"/>
            <a:ext cx="26116478" cy="9364362"/>
          </a:xfrm>
        </p:spPr>
        <p:txBody>
          <a:bodyPr/>
          <a:lstStyle>
            <a:lvl1pPr marL="0" indent="0">
              <a:buNone/>
              <a:defRPr sz="7948">
                <a:solidFill>
                  <a:schemeClr val="tx1"/>
                </a:solidFill>
              </a:defRPr>
            </a:lvl1pPr>
            <a:lvl2pPr marL="1514018" indent="0">
              <a:buNone/>
              <a:defRPr sz="6623">
                <a:solidFill>
                  <a:schemeClr val="tx1">
                    <a:tint val="75000"/>
                  </a:schemeClr>
                </a:solidFill>
              </a:defRPr>
            </a:lvl2pPr>
            <a:lvl3pPr marL="3028036" indent="0">
              <a:buNone/>
              <a:defRPr sz="5961">
                <a:solidFill>
                  <a:schemeClr val="tx1">
                    <a:tint val="75000"/>
                  </a:schemeClr>
                </a:solidFill>
              </a:defRPr>
            </a:lvl3pPr>
            <a:lvl4pPr marL="4542053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4pPr>
            <a:lvl5pPr marL="6056071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5pPr>
            <a:lvl6pPr marL="7570089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6pPr>
            <a:lvl7pPr marL="9084107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7pPr>
            <a:lvl8pPr marL="10598125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8pPr>
            <a:lvl9pPr marL="12112142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4157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1748" y="11395788"/>
            <a:ext cx="12868989" cy="2716161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9238" y="11395788"/>
            <a:ext cx="12868989" cy="2716161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6223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279167"/>
            <a:ext cx="26116478" cy="827433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5695" y="10494037"/>
            <a:ext cx="12809847" cy="5142966"/>
          </a:xfrm>
        </p:spPr>
        <p:txBody>
          <a:bodyPr anchor="b"/>
          <a:lstStyle>
            <a:lvl1pPr marL="0" indent="0">
              <a:buNone/>
              <a:defRPr sz="7948" b="1"/>
            </a:lvl1pPr>
            <a:lvl2pPr marL="1514018" indent="0">
              <a:buNone/>
              <a:defRPr sz="6623" b="1"/>
            </a:lvl2pPr>
            <a:lvl3pPr marL="3028036" indent="0">
              <a:buNone/>
              <a:defRPr sz="5961" b="1"/>
            </a:lvl3pPr>
            <a:lvl4pPr marL="4542053" indent="0">
              <a:buNone/>
              <a:defRPr sz="5298" b="1"/>
            </a:lvl4pPr>
            <a:lvl5pPr marL="6056071" indent="0">
              <a:buNone/>
              <a:defRPr sz="5298" b="1"/>
            </a:lvl5pPr>
            <a:lvl6pPr marL="7570089" indent="0">
              <a:buNone/>
              <a:defRPr sz="5298" b="1"/>
            </a:lvl6pPr>
            <a:lvl7pPr marL="9084107" indent="0">
              <a:buNone/>
              <a:defRPr sz="5298" b="1"/>
            </a:lvl7pPr>
            <a:lvl8pPr marL="10598125" indent="0">
              <a:buNone/>
              <a:defRPr sz="5298" b="1"/>
            </a:lvl8pPr>
            <a:lvl9pPr marL="12112142" indent="0">
              <a:buNone/>
              <a:defRPr sz="5298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5695" y="15637003"/>
            <a:ext cx="12809847" cy="2299967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9239" y="10494037"/>
            <a:ext cx="12872933" cy="5142966"/>
          </a:xfrm>
        </p:spPr>
        <p:txBody>
          <a:bodyPr anchor="b"/>
          <a:lstStyle>
            <a:lvl1pPr marL="0" indent="0">
              <a:buNone/>
              <a:defRPr sz="7948" b="1"/>
            </a:lvl1pPr>
            <a:lvl2pPr marL="1514018" indent="0">
              <a:buNone/>
              <a:defRPr sz="6623" b="1"/>
            </a:lvl2pPr>
            <a:lvl3pPr marL="3028036" indent="0">
              <a:buNone/>
              <a:defRPr sz="5961" b="1"/>
            </a:lvl3pPr>
            <a:lvl4pPr marL="4542053" indent="0">
              <a:buNone/>
              <a:defRPr sz="5298" b="1"/>
            </a:lvl4pPr>
            <a:lvl5pPr marL="6056071" indent="0">
              <a:buNone/>
              <a:defRPr sz="5298" b="1"/>
            </a:lvl5pPr>
            <a:lvl6pPr marL="7570089" indent="0">
              <a:buNone/>
              <a:defRPr sz="5298" b="1"/>
            </a:lvl6pPr>
            <a:lvl7pPr marL="9084107" indent="0">
              <a:buNone/>
              <a:defRPr sz="5298" b="1"/>
            </a:lvl7pPr>
            <a:lvl8pPr marL="10598125" indent="0">
              <a:buNone/>
              <a:defRPr sz="5298" b="1"/>
            </a:lvl8pPr>
            <a:lvl9pPr marL="12112142" indent="0">
              <a:buNone/>
              <a:defRPr sz="5298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9239" y="15637003"/>
            <a:ext cx="12872933" cy="22999676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7571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06239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0942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853902"/>
            <a:ext cx="9766080" cy="9988656"/>
          </a:xfrm>
        </p:spPr>
        <p:txBody>
          <a:bodyPr anchor="b"/>
          <a:lstStyle>
            <a:lvl1pPr>
              <a:defRPr sz="1059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72933" y="6163644"/>
            <a:ext cx="15329237" cy="30421799"/>
          </a:xfrm>
        </p:spPr>
        <p:txBody>
          <a:bodyPr/>
          <a:lstStyle>
            <a:lvl1pPr>
              <a:defRPr sz="10597"/>
            </a:lvl1pPr>
            <a:lvl2pPr>
              <a:defRPr sz="9272"/>
            </a:lvl2pPr>
            <a:lvl3pPr>
              <a:defRPr sz="7948"/>
            </a:lvl3pPr>
            <a:lvl4pPr>
              <a:defRPr sz="6623"/>
            </a:lvl4pPr>
            <a:lvl5pPr>
              <a:defRPr sz="6623"/>
            </a:lvl5pPr>
            <a:lvl6pPr>
              <a:defRPr sz="6623"/>
            </a:lvl6pPr>
            <a:lvl7pPr>
              <a:defRPr sz="6623"/>
            </a:lvl7pPr>
            <a:lvl8pPr>
              <a:defRPr sz="6623"/>
            </a:lvl8pPr>
            <a:lvl9pPr>
              <a:defRPr sz="6623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692" y="12842558"/>
            <a:ext cx="9766080" cy="23792426"/>
          </a:xfrm>
        </p:spPr>
        <p:txBody>
          <a:bodyPr/>
          <a:lstStyle>
            <a:lvl1pPr marL="0" indent="0">
              <a:buNone/>
              <a:defRPr sz="5298"/>
            </a:lvl1pPr>
            <a:lvl2pPr marL="1514018" indent="0">
              <a:buNone/>
              <a:defRPr sz="4636"/>
            </a:lvl2pPr>
            <a:lvl3pPr marL="3028036" indent="0">
              <a:buNone/>
              <a:defRPr sz="3974"/>
            </a:lvl3pPr>
            <a:lvl4pPr marL="4542053" indent="0">
              <a:buNone/>
              <a:defRPr sz="3312"/>
            </a:lvl4pPr>
            <a:lvl5pPr marL="6056071" indent="0">
              <a:buNone/>
              <a:defRPr sz="3312"/>
            </a:lvl5pPr>
            <a:lvl6pPr marL="7570089" indent="0">
              <a:buNone/>
              <a:defRPr sz="3312"/>
            </a:lvl6pPr>
            <a:lvl7pPr marL="9084107" indent="0">
              <a:buNone/>
              <a:defRPr sz="3312"/>
            </a:lvl7pPr>
            <a:lvl8pPr marL="10598125" indent="0">
              <a:buNone/>
              <a:defRPr sz="3312"/>
            </a:lvl8pPr>
            <a:lvl9pPr marL="12112142" indent="0">
              <a:buNone/>
              <a:defRPr sz="331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6739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853902"/>
            <a:ext cx="9766080" cy="9988656"/>
          </a:xfrm>
        </p:spPr>
        <p:txBody>
          <a:bodyPr anchor="b"/>
          <a:lstStyle>
            <a:lvl1pPr>
              <a:defRPr sz="10597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72933" y="6163644"/>
            <a:ext cx="15329237" cy="30421799"/>
          </a:xfrm>
        </p:spPr>
        <p:txBody>
          <a:bodyPr anchor="t"/>
          <a:lstStyle>
            <a:lvl1pPr marL="0" indent="0">
              <a:buNone/>
              <a:defRPr sz="10597"/>
            </a:lvl1pPr>
            <a:lvl2pPr marL="1514018" indent="0">
              <a:buNone/>
              <a:defRPr sz="9272"/>
            </a:lvl2pPr>
            <a:lvl3pPr marL="3028036" indent="0">
              <a:buNone/>
              <a:defRPr sz="7948"/>
            </a:lvl3pPr>
            <a:lvl4pPr marL="4542053" indent="0">
              <a:buNone/>
              <a:defRPr sz="6623"/>
            </a:lvl4pPr>
            <a:lvl5pPr marL="6056071" indent="0">
              <a:buNone/>
              <a:defRPr sz="6623"/>
            </a:lvl5pPr>
            <a:lvl6pPr marL="7570089" indent="0">
              <a:buNone/>
              <a:defRPr sz="6623"/>
            </a:lvl6pPr>
            <a:lvl7pPr marL="9084107" indent="0">
              <a:buNone/>
              <a:defRPr sz="6623"/>
            </a:lvl7pPr>
            <a:lvl8pPr marL="10598125" indent="0">
              <a:buNone/>
              <a:defRPr sz="6623"/>
            </a:lvl8pPr>
            <a:lvl9pPr marL="12112142" indent="0">
              <a:buNone/>
              <a:defRPr sz="662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692" y="12842558"/>
            <a:ext cx="9766080" cy="23792426"/>
          </a:xfrm>
        </p:spPr>
        <p:txBody>
          <a:bodyPr/>
          <a:lstStyle>
            <a:lvl1pPr marL="0" indent="0">
              <a:buNone/>
              <a:defRPr sz="5298"/>
            </a:lvl1pPr>
            <a:lvl2pPr marL="1514018" indent="0">
              <a:buNone/>
              <a:defRPr sz="4636"/>
            </a:lvl2pPr>
            <a:lvl3pPr marL="3028036" indent="0">
              <a:buNone/>
              <a:defRPr sz="3974"/>
            </a:lvl3pPr>
            <a:lvl4pPr marL="4542053" indent="0">
              <a:buNone/>
              <a:defRPr sz="3312"/>
            </a:lvl4pPr>
            <a:lvl5pPr marL="6056071" indent="0">
              <a:buNone/>
              <a:defRPr sz="3312"/>
            </a:lvl5pPr>
            <a:lvl6pPr marL="7570089" indent="0">
              <a:buNone/>
              <a:defRPr sz="3312"/>
            </a:lvl6pPr>
            <a:lvl7pPr marL="9084107" indent="0">
              <a:buNone/>
              <a:defRPr sz="3312"/>
            </a:lvl7pPr>
            <a:lvl8pPr marL="10598125" indent="0">
              <a:buNone/>
              <a:defRPr sz="3312"/>
            </a:lvl8pPr>
            <a:lvl9pPr marL="12112142" indent="0">
              <a:buNone/>
              <a:defRPr sz="3312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1947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1749" y="2279167"/>
            <a:ext cx="26116478" cy="8274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1749" y="11395788"/>
            <a:ext cx="26116478" cy="271616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1748" y="39677170"/>
            <a:ext cx="6812994" cy="22791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D42BD-E2EF-4275-95F0-06C42E55F043}" type="datetimeFigureOut">
              <a:rPr lang="de-DE" smtClean="0"/>
              <a:t>15.01.2026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30242" y="39677170"/>
            <a:ext cx="10219492" cy="22791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85233" y="39677170"/>
            <a:ext cx="6812994" cy="22791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0702BA-A8E9-47CB-B490-8BD637EE4A5A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87256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3028036" rtl="0" eaLnBrk="1" latinLnBrk="0" hangingPunct="1">
        <a:lnSpc>
          <a:spcPct val="90000"/>
        </a:lnSpc>
        <a:spcBef>
          <a:spcPct val="0"/>
        </a:spcBef>
        <a:buNone/>
        <a:defRPr sz="145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7009" indent="-757009" algn="l" defTabSz="3028036" rtl="0" eaLnBrk="1" latinLnBrk="0" hangingPunct="1">
        <a:lnSpc>
          <a:spcPct val="90000"/>
        </a:lnSpc>
        <a:spcBef>
          <a:spcPts val="3312"/>
        </a:spcBef>
        <a:buFont typeface="Arial" panose="020B0604020202020204" pitchFamily="34" charset="0"/>
        <a:buChar char="•"/>
        <a:defRPr sz="9272" kern="1200">
          <a:solidFill>
            <a:schemeClr val="tx1"/>
          </a:solidFill>
          <a:latin typeface="+mn-lt"/>
          <a:ea typeface="+mn-ea"/>
          <a:cs typeface="+mn-cs"/>
        </a:defRPr>
      </a:lvl1pPr>
      <a:lvl2pPr marL="2271027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7948" kern="1200">
          <a:solidFill>
            <a:schemeClr val="tx1"/>
          </a:solidFill>
          <a:latin typeface="+mn-lt"/>
          <a:ea typeface="+mn-ea"/>
          <a:cs typeface="+mn-cs"/>
        </a:defRPr>
      </a:lvl2pPr>
      <a:lvl3pPr marL="3785045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6623" kern="1200">
          <a:solidFill>
            <a:schemeClr val="tx1"/>
          </a:solidFill>
          <a:latin typeface="+mn-lt"/>
          <a:ea typeface="+mn-ea"/>
          <a:cs typeface="+mn-cs"/>
        </a:defRPr>
      </a:lvl3pPr>
      <a:lvl4pPr marL="5299062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4pPr>
      <a:lvl5pPr marL="6813080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5pPr>
      <a:lvl6pPr marL="8327098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6pPr>
      <a:lvl7pPr marL="9841116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7pPr>
      <a:lvl8pPr marL="11355134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8pPr>
      <a:lvl9pPr marL="12869151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1pPr>
      <a:lvl2pPr marL="1514018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2pPr>
      <a:lvl3pPr marL="3028036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3pPr>
      <a:lvl4pPr marL="4542053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4pPr>
      <a:lvl5pPr marL="6056071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5pPr>
      <a:lvl6pPr marL="7570089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6pPr>
      <a:lvl7pPr marL="9084107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7pPr>
      <a:lvl8pPr marL="10598125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8pPr>
      <a:lvl9pPr marL="12112142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jpg"/><Relationship Id="rId3" Type="http://schemas.openxmlformats.org/officeDocument/2006/relationships/image" Target="../media/image11.emf"/><Relationship Id="rId7" Type="http://schemas.openxmlformats.org/officeDocument/2006/relationships/image" Target="../media/image13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2.png"/><Relationship Id="rId5" Type="http://schemas.openxmlformats.org/officeDocument/2006/relationships/image" Target="../media/image10.emf"/><Relationship Id="rId4" Type="http://schemas.openxmlformats.org/officeDocument/2006/relationships/oleObject" Target="../embeddings/oleObject3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png"/><Relationship Id="rId7" Type="http://schemas.openxmlformats.org/officeDocument/2006/relationships/image" Target="../media/image20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11" Type="http://schemas.openxmlformats.org/officeDocument/2006/relationships/image" Target="../media/image24.png"/><Relationship Id="rId5" Type="http://schemas.openxmlformats.org/officeDocument/2006/relationships/image" Target="../media/image18.png"/><Relationship Id="rId10" Type="http://schemas.openxmlformats.org/officeDocument/2006/relationships/image" Target="../media/image23.png"/><Relationship Id="rId4" Type="http://schemas.openxmlformats.org/officeDocument/2006/relationships/image" Target="../media/image17.png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Grafik 23" descr="Ein Bild, das Dunkelheit, Nacht enthält.&#10;&#10;KI-generierte Inhalte können fehlerhaft sein.">
            <a:extLst>
              <a:ext uri="{FF2B5EF4-FFF2-40B4-BE49-F238E27FC236}">
                <a16:creationId xmlns:a16="http://schemas.microsoft.com/office/drawing/2014/main" id="{39CE8977-236C-795E-6AD3-E57C3920C71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833509" y="1282074"/>
            <a:ext cx="14692762" cy="10222992"/>
          </a:xfrm>
          <a:prstGeom prst="rect">
            <a:avLst/>
          </a:prstGeom>
        </p:spPr>
      </p:pic>
      <p:sp>
        <p:nvSpPr>
          <p:cNvPr id="228" name="Textfeld 227"/>
          <p:cNvSpPr txBox="1"/>
          <p:nvPr/>
        </p:nvSpPr>
        <p:spPr>
          <a:xfrm>
            <a:off x="906165" y="862069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Gruppieren 21">
            <a:extLst>
              <a:ext uri="{FF2B5EF4-FFF2-40B4-BE49-F238E27FC236}">
                <a16:creationId xmlns:a16="http://schemas.microsoft.com/office/drawing/2014/main" id="{486BDADD-B41B-E477-1140-9A7295661E46}"/>
              </a:ext>
            </a:extLst>
          </p:cNvPr>
          <p:cNvGrpSpPr/>
          <p:nvPr/>
        </p:nvGrpSpPr>
        <p:grpSpPr>
          <a:xfrm>
            <a:off x="22283530" y="1771546"/>
            <a:ext cx="1353395" cy="1316079"/>
            <a:chOff x="1604696" y="21985736"/>
            <a:chExt cx="1353395" cy="1316079"/>
          </a:xfrm>
        </p:grpSpPr>
        <p:pic>
          <p:nvPicPr>
            <p:cNvPr id="13" name="Grafik 12"/>
            <p:cNvPicPr>
              <a:picLocks noChangeAspect="1"/>
            </p:cNvPicPr>
            <p:nvPr/>
          </p:nvPicPr>
          <p:blipFill rotWithShape="1"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6000"/>
                      </a14:imgEffect>
                      <a14:imgEffect>
                        <a14:brightnessContrast bright="-41000" contrast="81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20646076">
              <a:off x="1604696" y="21985736"/>
              <a:ext cx="1348752" cy="1316079"/>
            </a:xfrm>
            <a:prstGeom prst="rect">
              <a:avLst/>
            </a:prstGeom>
          </p:spPr>
        </p:pic>
        <p:sp>
          <p:nvSpPr>
            <p:cNvPr id="14" name="Freihandform 13"/>
            <p:cNvSpPr/>
            <p:nvPr/>
          </p:nvSpPr>
          <p:spPr>
            <a:xfrm rot="1549837" flipV="1">
              <a:off x="2093963" y="23114314"/>
              <a:ext cx="223151" cy="41720"/>
            </a:xfrm>
            <a:custGeom>
              <a:avLst/>
              <a:gdLst>
                <a:gd name="connsiteX0" fmla="*/ 0 w 247650"/>
                <a:gd name="connsiteY0" fmla="*/ 0 h 105833"/>
                <a:gd name="connsiteX1" fmla="*/ 85725 w 247650"/>
                <a:gd name="connsiteY1" fmla="*/ 28575 h 105833"/>
                <a:gd name="connsiteX2" fmla="*/ 123825 w 247650"/>
                <a:gd name="connsiteY2" fmla="*/ 95250 h 105833"/>
                <a:gd name="connsiteX3" fmla="*/ 180975 w 247650"/>
                <a:gd name="connsiteY3" fmla="*/ 28575 h 105833"/>
                <a:gd name="connsiteX4" fmla="*/ 219075 w 247650"/>
                <a:gd name="connsiteY4" fmla="*/ 95250 h 105833"/>
                <a:gd name="connsiteX5" fmla="*/ 247650 w 247650"/>
                <a:gd name="connsiteY5" fmla="*/ 104775 h 105833"/>
                <a:gd name="connsiteX0" fmla="*/ 0 w 192440"/>
                <a:gd name="connsiteY0" fmla="*/ 0 h 123472"/>
                <a:gd name="connsiteX1" fmla="*/ 30515 w 192440"/>
                <a:gd name="connsiteY1" fmla="*/ 46214 h 123472"/>
                <a:gd name="connsiteX2" fmla="*/ 68615 w 192440"/>
                <a:gd name="connsiteY2" fmla="*/ 112889 h 123472"/>
                <a:gd name="connsiteX3" fmla="*/ 125765 w 192440"/>
                <a:gd name="connsiteY3" fmla="*/ 46214 h 123472"/>
                <a:gd name="connsiteX4" fmla="*/ 163865 w 192440"/>
                <a:gd name="connsiteY4" fmla="*/ 112889 h 123472"/>
                <a:gd name="connsiteX5" fmla="*/ 192440 w 192440"/>
                <a:gd name="connsiteY5" fmla="*/ 122414 h 123472"/>
                <a:gd name="connsiteX0" fmla="*/ 0 w 192440"/>
                <a:gd name="connsiteY0" fmla="*/ 0 h 97013"/>
                <a:gd name="connsiteX1" fmla="*/ 30515 w 192440"/>
                <a:gd name="connsiteY1" fmla="*/ 19755 h 97013"/>
                <a:gd name="connsiteX2" fmla="*/ 68615 w 192440"/>
                <a:gd name="connsiteY2" fmla="*/ 86430 h 97013"/>
                <a:gd name="connsiteX3" fmla="*/ 125765 w 192440"/>
                <a:gd name="connsiteY3" fmla="*/ 19755 h 97013"/>
                <a:gd name="connsiteX4" fmla="*/ 163865 w 192440"/>
                <a:gd name="connsiteY4" fmla="*/ 86430 h 97013"/>
                <a:gd name="connsiteX5" fmla="*/ 192440 w 192440"/>
                <a:gd name="connsiteY5" fmla="*/ 95955 h 97013"/>
                <a:gd name="connsiteX0" fmla="*/ 0 w 258692"/>
                <a:gd name="connsiteY0" fmla="*/ 68440 h 77259"/>
                <a:gd name="connsiteX1" fmla="*/ 96767 w 258692"/>
                <a:gd name="connsiteY1" fmla="*/ 1 h 77259"/>
                <a:gd name="connsiteX2" fmla="*/ 134867 w 258692"/>
                <a:gd name="connsiteY2" fmla="*/ 66676 h 77259"/>
                <a:gd name="connsiteX3" fmla="*/ 192017 w 258692"/>
                <a:gd name="connsiteY3" fmla="*/ 1 h 77259"/>
                <a:gd name="connsiteX4" fmla="*/ 230117 w 258692"/>
                <a:gd name="connsiteY4" fmla="*/ 66676 h 77259"/>
                <a:gd name="connsiteX5" fmla="*/ 258692 w 258692"/>
                <a:gd name="connsiteY5" fmla="*/ 76201 h 77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258692" h="77259">
                  <a:moveTo>
                    <a:pt x="0" y="68440"/>
                  </a:moveTo>
                  <a:cubicBezTo>
                    <a:pt x="32544" y="74790"/>
                    <a:pt x="74289" y="295"/>
                    <a:pt x="96767" y="1"/>
                  </a:cubicBezTo>
                  <a:cubicBezTo>
                    <a:pt x="119245" y="-293"/>
                    <a:pt x="118992" y="66676"/>
                    <a:pt x="134867" y="66676"/>
                  </a:cubicBezTo>
                  <a:cubicBezTo>
                    <a:pt x="150742" y="66676"/>
                    <a:pt x="176142" y="1"/>
                    <a:pt x="192017" y="1"/>
                  </a:cubicBezTo>
                  <a:cubicBezTo>
                    <a:pt x="207892" y="1"/>
                    <a:pt x="219005" y="53976"/>
                    <a:pt x="230117" y="66676"/>
                  </a:cubicBezTo>
                  <a:cubicBezTo>
                    <a:pt x="241229" y="79376"/>
                    <a:pt x="249960" y="77788"/>
                    <a:pt x="258692" y="76201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Freihandform 14"/>
            <p:cNvSpPr/>
            <p:nvPr/>
          </p:nvSpPr>
          <p:spPr>
            <a:xfrm rot="17288627" flipV="1">
              <a:off x="2825655" y="22767546"/>
              <a:ext cx="223151" cy="41720"/>
            </a:xfrm>
            <a:custGeom>
              <a:avLst/>
              <a:gdLst>
                <a:gd name="connsiteX0" fmla="*/ 0 w 247650"/>
                <a:gd name="connsiteY0" fmla="*/ 0 h 105833"/>
                <a:gd name="connsiteX1" fmla="*/ 85725 w 247650"/>
                <a:gd name="connsiteY1" fmla="*/ 28575 h 105833"/>
                <a:gd name="connsiteX2" fmla="*/ 123825 w 247650"/>
                <a:gd name="connsiteY2" fmla="*/ 95250 h 105833"/>
                <a:gd name="connsiteX3" fmla="*/ 180975 w 247650"/>
                <a:gd name="connsiteY3" fmla="*/ 28575 h 105833"/>
                <a:gd name="connsiteX4" fmla="*/ 219075 w 247650"/>
                <a:gd name="connsiteY4" fmla="*/ 95250 h 105833"/>
                <a:gd name="connsiteX5" fmla="*/ 247650 w 247650"/>
                <a:gd name="connsiteY5" fmla="*/ 104775 h 105833"/>
                <a:gd name="connsiteX0" fmla="*/ 0 w 192440"/>
                <a:gd name="connsiteY0" fmla="*/ 0 h 123472"/>
                <a:gd name="connsiteX1" fmla="*/ 30515 w 192440"/>
                <a:gd name="connsiteY1" fmla="*/ 46214 h 123472"/>
                <a:gd name="connsiteX2" fmla="*/ 68615 w 192440"/>
                <a:gd name="connsiteY2" fmla="*/ 112889 h 123472"/>
                <a:gd name="connsiteX3" fmla="*/ 125765 w 192440"/>
                <a:gd name="connsiteY3" fmla="*/ 46214 h 123472"/>
                <a:gd name="connsiteX4" fmla="*/ 163865 w 192440"/>
                <a:gd name="connsiteY4" fmla="*/ 112889 h 123472"/>
                <a:gd name="connsiteX5" fmla="*/ 192440 w 192440"/>
                <a:gd name="connsiteY5" fmla="*/ 122414 h 123472"/>
                <a:gd name="connsiteX0" fmla="*/ 0 w 192440"/>
                <a:gd name="connsiteY0" fmla="*/ 0 h 97013"/>
                <a:gd name="connsiteX1" fmla="*/ 30515 w 192440"/>
                <a:gd name="connsiteY1" fmla="*/ 19755 h 97013"/>
                <a:gd name="connsiteX2" fmla="*/ 68615 w 192440"/>
                <a:gd name="connsiteY2" fmla="*/ 86430 h 97013"/>
                <a:gd name="connsiteX3" fmla="*/ 125765 w 192440"/>
                <a:gd name="connsiteY3" fmla="*/ 19755 h 97013"/>
                <a:gd name="connsiteX4" fmla="*/ 163865 w 192440"/>
                <a:gd name="connsiteY4" fmla="*/ 86430 h 97013"/>
                <a:gd name="connsiteX5" fmla="*/ 192440 w 192440"/>
                <a:gd name="connsiteY5" fmla="*/ 95955 h 97013"/>
                <a:gd name="connsiteX0" fmla="*/ 0 w 258692"/>
                <a:gd name="connsiteY0" fmla="*/ 68440 h 77259"/>
                <a:gd name="connsiteX1" fmla="*/ 96767 w 258692"/>
                <a:gd name="connsiteY1" fmla="*/ 1 h 77259"/>
                <a:gd name="connsiteX2" fmla="*/ 134867 w 258692"/>
                <a:gd name="connsiteY2" fmla="*/ 66676 h 77259"/>
                <a:gd name="connsiteX3" fmla="*/ 192017 w 258692"/>
                <a:gd name="connsiteY3" fmla="*/ 1 h 77259"/>
                <a:gd name="connsiteX4" fmla="*/ 230117 w 258692"/>
                <a:gd name="connsiteY4" fmla="*/ 66676 h 77259"/>
                <a:gd name="connsiteX5" fmla="*/ 258692 w 258692"/>
                <a:gd name="connsiteY5" fmla="*/ 76201 h 7725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258692" h="77259">
                  <a:moveTo>
                    <a:pt x="0" y="68440"/>
                  </a:moveTo>
                  <a:cubicBezTo>
                    <a:pt x="32544" y="74790"/>
                    <a:pt x="74289" y="295"/>
                    <a:pt x="96767" y="1"/>
                  </a:cubicBezTo>
                  <a:cubicBezTo>
                    <a:pt x="119245" y="-293"/>
                    <a:pt x="118992" y="66676"/>
                    <a:pt x="134867" y="66676"/>
                  </a:cubicBezTo>
                  <a:cubicBezTo>
                    <a:pt x="150742" y="66676"/>
                    <a:pt x="176142" y="1"/>
                    <a:pt x="192017" y="1"/>
                  </a:cubicBezTo>
                  <a:cubicBezTo>
                    <a:pt x="207892" y="1"/>
                    <a:pt x="219005" y="53976"/>
                    <a:pt x="230117" y="66676"/>
                  </a:cubicBezTo>
                  <a:cubicBezTo>
                    <a:pt x="241229" y="79376"/>
                    <a:pt x="249960" y="77788"/>
                    <a:pt x="258692" y="76201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16" name="Textfeld 15"/>
          <p:cNvSpPr txBox="1"/>
          <p:nvPr/>
        </p:nvSpPr>
        <p:spPr>
          <a:xfrm>
            <a:off x="15388225" y="862068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40988" y="21041415"/>
            <a:ext cx="28859883" cy="37856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Figure S1: MS/MS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pectra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highlight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b- and y-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ion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(A) SP1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unlabel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, (B) DNIQGITKPAIR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2PCA. Plots were generated in </a:t>
            </a:r>
            <a:r>
              <a:rPr lang="de-DE" sz="4000" dirty="0" smtClean="0">
                <a:latin typeface="Arial" panose="020B0604020202020204" pitchFamily="34" charset="0"/>
                <a:cs typeface="Arial" panose="020B0604020202020204" pitchFamily="34" charset="0"/>
              </a:rPr>
              <a:t>Python 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using the pyteomics package.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reshold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200 (A) and 40 (B).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Matching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oretical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masse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oleranc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0.3 Da.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annotation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equenc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(top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individual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respectiv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oretical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fragment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ion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i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4000" i="1" dirty="0">
                <a:latin typeface="Arial" panose="020B0604020202020204" pitchFamily="34" charset="0"/>
                <a:cs typeface="Arial" panose="020B0604020202020204" pitchFamily="34" charset="0"/>
              </a:rPr>
              <a:t>z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printed. (C)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Zoom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MS1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Figure 1B SP1 + pip2PCA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reaction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peak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corresponding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double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SP1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low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intensity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aqueous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4000" dirty="0" err="1">
                <a:latin typeface="Arial" panose="020B0604020202020204" pitchFamily="34" charset="0"/>
                <a:cs typeface="Arial" panose="020B0604020202020204" pitchFamily="34" charset="0"/>
              </a:rPr>
              <a:t>dilution</a:t>
            </a:r>
            <a:r>
              <a:rPr lang="de-DE" sz="4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4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A50A35B4-FD99-3979-98C1-DB7A55E8A9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39186" y="1281660"/>
            <a:ext cx="14713776" cy="10223820"/>
          </a:xfrm>
          <a:prstGeom prst="rect">
            <a:avLst/>
          </a:prstGeom>
        </p:spPr>
      </p:pic>
      <p:pic>
        <p:nvPicPr>
          <p:cNvPr id="26" name="Grafik 25" descr="Ein Bild, das Text, Screenshot, Uhr enthält.&#10;&#10;KI-generierte Inhalte können fehlerhaft sein.">
            <a:extLst>
              <a:ext uri="{FF2B5EF4-FFF2-40B4-BE49-F238E27FC236}">
                <a16:creationId xmlns:a16="http://schemas.microsoft.com/office/drawing/2014/main" id="{4076DA86-1E7A-D494-A5F1-3B7D3FF1C18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318498" y="1937584"/>
            <a:ext cx="6309373" cy="2651765"/>
          </a:xfrm>
          <a:prstGeom prst="rect">
            <a:avLst/>
          </a:prstGeom>
        </p:spPr>
      </p:pic>
      <p:pic>
        <p:nvPicPr>
          <p:cNvPr id="3" name="Grafik 2" descr="Ein Bild, das Uhr, Text enthält.&#10;&#10;KI-generierte Inhalte können fehlerhaft sein.">
            <a:extLst>
              <a:ext uri="{FF2B5EF4-FFF2-40B4-BE49-F238E27FC236}">
                <a16:creationId xmlns:a16="http://schemas.microsoft.com/office/drawing/2014/main" id="{2C3134FA-E3D0-8182-2E2B-33EF192D8C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00259" y="1437057"/>
            <a:ext cx="6309373" cy="2651765"/>
          </a:xfrm>
          <a:prstGeom prst="rect">
            <a:avLst/>
          </a:prstGeom>
        </p:spPr>
      </p:pic>
      <p:pic>
        <p:nvPicPr>
          <p:cNvPr id="2" name="Bild 1">
            <a:extLst>
              <a:ext uri="{FF2B5EF4-FFF2-40B4-BE49-F238E27FC236}">
                <a16:creationId xmlns:a16="http://schemas.microsoft.com/office/drawing/2014/main" id="{CD94F8FE-9460-54E9-C808-65F64E83550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6165" y="12448751"/>
            <a:ext cx="10920075" cy="8493392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7EFC819B-80E8-14E8-FBF3-385FCFCBC0FF}"/>
              </a:ext>
            </a:extLst>
          </p:cNvPr>
          <p:cNvSpPr txBox="1"/>
          <p:nvPr/>
        </p:nvSpPr>
        <p:spPr>
          <a:xfrm>
            <a:off x="906165" y="11682798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5583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906165" y="2119369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/>
          <p:cNvSpPr txBox="1"/>
          <p:nvPr/>
        </p:nvSpPr>
        <p:spPr>
          <a:xfrm>
            <a:off x="906165" y="7858228"/>
            <a:ext cx="1928225" cy="707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62312" y="24102536"/>
            <a:ext cx="287089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3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3000" b="1" dirty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: Pyr-2PCA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ynthe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NMR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. (A) Synthesis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pyr-2PCA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pyr-2PCA, including MS1 spectrum and </a:t>
            </a:r>
            <a:r>
              <a:rPr lang="en-US" sz="30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H NMR (400 MHz, DMSO-</a:t>
            </a:r>
            <a:r>
              <a:rPr lang="en-US" sz="3000" i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30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) spectrum.</a:t>
            </a:r>
            <a:endParaRPr lang="de-DE" sz="3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430306" y="2796987"/>
            <a:ext cx="73799822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4008199"/>
              </p:ext>
            </p:extLst>
          </p:nvPr>
        </p:nvGraphicFramePr>
        <p:xfrm>
          <a:off x="2944905" y="2842706"/>
          <a:ext cx="22549657" cy="41867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6" name="CS ChemDraw Drawing" r:id="rId3" imgW="7895396" imgH="1468855" progId="ChemDraw.Document.6.0">
                  <p:embed/>
                </p:oleObj>
              </mc:Choice>
              <mc:Fallback>
                <p:oleObj name="CS ChemDraw Drawing" r:id="rId3" imgW="7895396" imgH="1468855" progId="ChemDraw.Document.6.0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44905" y="2842706"/>
                        <a:ext cx="22549657" cy="4186744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tangle 4"/>
          <p:cNvSpPr>
            <a:spLocks noChangeArrowheads="1"/>
          </p:cNvSpPr>
          <p:nvPr/>
        </p:nvSpPr>
        <p:spPr bwMode="auto">
          <a:xfrm>
            <a:off x="1461126" y="8566115"/>
            <a:ext cx="96283027" cy="50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5735581"/>
              </p:ext>
            </p:extLst>
          </p:nvPr>
        </p:nvGraphicFramePr>
        <p:xfrm>
          <a:off x="1262962" y="14263872"/>
          <a:ext cx="27025506" cy="93637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7" r:id="rId5" imgW="10353739" imgH="3609802" progId="MestReNova.Document.1">
                  <p:embed/>
                </p:oleObj>
              </mc:Choice>
              <mc:Fallback>
                <p:oleObj r:id="rId5" imgW="10353739" imgH="3609802" progId="MestReNova.Document.1">
                  <p:embed/>
                  <p:pic>
                    <p:nvPicPr>
                      <p:cNvPr id="0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262962" y="14263872"/>
                        <a:ext cx="27025506" cy="9363767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9" name="Picture 3">
            <a:extLst>
              <a:ext uri="{FF2B5EF4-FFF2-40B4-BE49-F238E27FC236}">
                <a16:creationId xmlns:a16="http://schemas.microsoft.com/office/drawing/2014/main" id="{FEA75E5D-E490-37A8-EDF9-1FABF4454BA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4909"/>
          <a:stretch/>
        </p:blipFill>
        <p:spPr>
          <a:xfrm>
            <a:off x="338866" y="9191212"/>
            <a:ext cx="27949602" cy="4497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1566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457370" y="28940727"/>
            <a:ext cx="2814524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3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3000" b="1" dirty="0">
                <a:latin typeface="Arial" panose="020B0604020202020204" pitchFamily="34" charset="0"/>
                <a:cs typeface="Arial" panose="020B0604020202020204" pitchFamily="34" charset="0"/>
              </a:rPr>
              <a:t> S3: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Dma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Pyr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-GG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ynthe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NMR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MS. (A) Synthesis route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dma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pyr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-GG. (B) MS1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TimsTOF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Flex after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hort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term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torage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exhibiting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shift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16 Da. (C) MS1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mas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pectrum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directly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3000" dirty="0" err="1">
                <a:latin typeface="Arial" panose="020B0604020202020204" pitchFamily="34" charset="0"/>
                <a:cs typeface="Arial" panose="020B0604020202020204" pitchFamily="34" charset="0"/>
              </a:rPr>
              <a:t>synthesis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sz="30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H NMR (400 MHz, CD</a:t>
            </a:r>
            <a:r>
              <a:rPr lang="en-US" sz="30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OD) spectrum of </a:t>
            </a:r>
            <a:r>
              <a:rPr lang="en-US" sz="3000" dirty="0" err="1">
                <a:latin typeface="Arial" panose="020B0604020202020204" pitchFamily="34" charset="0"/>
                <a:cs typeface="Arial" panose="020B0604020202020204" pitchFamily="34" charset="0"/>
              </a:rPr>
              <a:t>dma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3000" dirty="0" err="1">
                <a:latin typeface="Arial" panose="020B0604020202020204" pitchFamily="34" charset="0"/>
                <a:cs typeface="Arial" panose="020B0604020202020204" pitchFamily="34" charset="0"/>
              </a:rPr>
              <a:t>pyr</a:t>
            </a:r>
            <a:r>
              <a:rPr lang="en-US" sz="3000" dirty="0">
                <a:latin typeface="Arial" panose="020B0604020202020204" pitchFamily="34" charset="0"/>
                <a:cs typeface="Arial" panose="020B0604020202020204" pitchFamily="34" charset="0"/>
              </a:rPr>
              <a:t>-GG.</a:t>
            </a:r>
            <a:endParaRPr lang="de-DE" sz="3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Bild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47603" y="899385"/>
            <a:ext cx="11712005" cy="9109337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ctangle 16"/>
          <p:cNvSpPr>
            <a:spLocks noChangeArrowheads="1"/>
          </p:cNvSpPr>
          <p:nvPr/>
        </p:nvSpPr>
        <p:spPr bwMode="auto">
          <a:xfrm>
            <a:off x="1398798" y="707697"/>
            <a:ext cx="75551177" cy="457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649391"/>
              </p:ext>
            </p:extLst>
          </p:nvPr>
        </p:nvGraphicFramePr>
        <p:xfrm>
          <a:off x="1068495" y="364927"/>
          <a:ext cx="15508692" cy="103718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5" name="CS ChemDraw Drawing" r:id="rId4" imgW="8844937" imgH="5917355" progId="ChemDraw.Document.6.0">
                  <p:embed/>
                </p:oleObj>
              </mc:Choice>
              <mc:Fallback>
                <p:oleObj name="CS ChemDraw Drawing" r:id="rId4" imgW="8844937" imgH="5917355" progId="ChemDraw.Document.6.0">
                  <p:embed/>
                  <p:pic>
                    <p:nvPicPr>
                      <p:cNvPr id="0" name="Object 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68495" y="364927"/>
                        <a:ext cx="15508692" cy="10371899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5794" y="19088346"/>
            <a:ext cx="27846818" cy="9401276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457371" y="307691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5943377" y="307691"/>
            <a:ext cx="1928225" cy="707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457371" y="9951378"/>
            <a:ext cx="554960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4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4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2">
            <a:extLst>
              <a:ext uri="{FF2B5EF4-FFF2-40B4-BE49-F238E27FC236}">
                <a16:creationId xmlns:a16="http://schemas.microsoft.com/office/drawing/2014/main" id="{03E577B0-2EE0-8083-0C1A-7B0ED09F786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55794" y="10895727"/>
            <a:ext cx="26891113" cy="7829324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73175430-E220-B2BB-50F5-D1D86AE2754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63" t="9699" r="4282" b="56650"/>
          <a:stretch/>
        </p:blipFill>
        <p:spPr>
          <a:xfrm>
            <a:off x="23516876" y="3516923"/>
            <a:ext cx="3365007" cy="2051148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0BA2CE9B-9614-9326-2E4C-2C2A58791BB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63" t="9699" r="4282" b="56650"/>
          <a:stretch/>
        </p:blipFill>
        <p:spPr>
          <a:xfrm>
            <a:off x="8194815" y="11799615"/>
            <a:ext cx="3365007" cy="2051148"/>
          </a:xfrm>
          <a:prstGeom prst="rect">
            <a:avLst/>
          </a:prstGeom>
        </p:spPr>
      </p:pic>
      <p:sp>
        <p:nvSpPr>
          <p:cNvPr id="15" name="Rechteck 14">
            <a:extLst>
              <a:ext uri="{FF2B5EF4-FFF2-40B4-BE49-F238E27FC236}">
                <a16:creationId xmlns:a16="http://schemas.microsoft.com/office/drawing/2014/main" id="{664AF8DC-90B0-C136-C9B1-163B7864A12C}"/>
              </a:ext>
            </a:extLst>
          </p:cNvPr>
          <p:cNvSpPr/>
          <p:nvPr/>
        </p:nvSpPr>
        <p:spPr>
          <a:xfrm>
            <a:off x="8543732" y="11933788"/>
            <a:ext cx="300942" cy="1967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7EDE57FB-B042-CEDC-BB5E-86FC3ED9E86B}"/>
              </a:ext>
            </a:extLst>
          </p:cNvPr>
          <p:cNvSpPr txBox="1"/>
          <p:nvPr/>
        </p:nvSpPr>
        <p:spPr>
          <a:xfrm>
            <a:off x="8463914" y="11915775"/>
            <a:ext cx="30094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57660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565079" y="26141368"/>
            <a:ext cx="2656081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3000" b="1" dirty="0">
                <a:latin typeface="Arial" panose="020B0604020202020204" pitchFamily="34" charset="0"/>
                <a:cs typeface="Arial" panose="020B0604020202020204" pitchFamily="34" charset="0"/>
              </a:rPr>
              <a:t>Figure S4: 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Mean, RMS-normalized spectra of one spot measured in LALDI or MALDI imaging mode, respectively, of </a:t>
            </a:r>
            <a:r>
              <a:rPr lang="de-DE" sz="3000" dirty="0" smtClean="0">
                <a:latin typeface="Arial" panose="020B0604020202020204" pitchFamily="34" charset="0"/>
                <a:cs typeface="Arial" panose="020B0604020202020204" pitchFamily="34" charset="0"/>
              </a:rPr>
              <a:t>dma-pyr-GG </a:t>
            </a:r>
            <a:r>
              <a:rPr lang="de-DE" sz="3000" dirty="0">
                <a:latin typeface="Arial" panose="020B0604020202020204" pitchFamily="34" charset="0"/>
                <a:cs typeface="Arial" panose="020B0604020202020204" pitchFamily="34" charset="0"/>
              </a:rPr>
              <a:t>mixed with different ratios to five spike-in peptides (see section 2.6). </a:t>
            </a:r>
          </a:p>
        </p:txBody>
      </p:sp>
      <p:grpSp>
        <p:nvGrpSpPr>
          <p:cNvPr id="21" name="Gruppieren 20"/>
          <p:cNvGrpSpPr/>
          <p:nvPr/>
        </p:nvGrpSpPr>
        <p:grpSpPr>
          <a:xfrm>
            <a:off x="930495" y="1444355"/>
            <a:ext cx="27489903" cy="24216903"/>
            <a:chOff x="930495" y="1444355"/>
            <a:chExt cx="27489903" cy="24216903"/>
          </a:xfrm>
        </p:grpSpPr>
        <p:pic>
          <p:nvPicPr>
            <p:cNvPr id="5" name="Grafik 4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2584" y="1444355"/>
              <a:ext cx="12613238" cy="4782765"/>
            </a:xfrm>
            <a:prstGeom prst="rect">
              <a:avLst/>
            </a:prstGeom>
          </p:spPr>
        </p:pic>
        <p:pic>
          <p:nvPicPr>
            <p:cNvPr id="6" name="Grafik 5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07160" y="1444355"/>
              <a:ext cx="12613238" cy="4782765"/>
            </a:xfrm>
            <a:prstGeom prst="rect">
              <a:avLst/>
            </a:prstGeom>
          </p:spPr>
        </p:pic>
        <p:sp>
          <p:nvSpPr>
            <p:cNvPr id="8" name="Textfeld 7"/>
            <p:cNvSpPr txBox="1"/>
            <p:nvPr/>
          </p:nvSpPr>
          <p:spPr>
            <a:xfrm>
              <a:off x="930495" y="3512572"/>
              <a:ext cx="221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err="1"/>
                <a:t>Dil</a:t>
              </a:r>
              <a:r>
                <a:rPr lang="de-DE" sz="3600" dirty="0"/>
                <a:t> 1</a:t>
              </a: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930495" y="8371107"/>
              <a:ext cx="221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err="1"/>
                <a:t>Dil</a:t>
              </a:r>
              <a:r>
                <a:rPr lang="de-DE" sz="3600" dirty="0"/>
                <a:t> 2</a:t>
              </a: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930495" y="13229642"/>
              <a:ext cx="221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err="1"/>
                <a:t>Dil</a:t>
              </a:r>
              <a:r>
                <a:rPr lang="de-DE" sz="3600" dirty="0"/>
                <a:t> 3</a:t>
              </a: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930495" y="18088177"/>
              <a:ext cx="221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err="1"/>
                <a:t>Dil</a:t>
              </a:r>
              <a:r>
                <a:rPr lang="de-DE" sz="3600" dirty="0"/>
                <a:t> 4</a:t>
              </a: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930495" y="22946710"/>
              <a:ext cx="2216463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600" dirty="0" err="1"/>
                <a:t>Dil</a:t>
              </a:r>
              <a:r>
                <a:rPr lang="de-DE" sz="3600" dirty="0"/>
                <a:t> 5</a:t>
              </a:r>
            </a:p>
          </p:txBody>
        </p:sp>
        <p:pic>
          <p:nvPicPr>
            <p:cNvPr id="13" name="Grafik 1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07160" y="6302890"/>
              <a:ext cx="12613238" cy="4782765"/>
            </a:xfrm>
            <a:prstGeom prst="rect">
              <a:avLst/>
            </a:prstGeom>
          </p:spPr>
        </p:pic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2584" y="6302890"/>
              <a:ext cx="12613238" cy="4782765"/>
            </a:xfrm>
            <a:prstGeom prst="rect">
              <a:avLst/>
            </a:prstGeom>
          </p:spPr>
        </p:pic>
        <p:pic>
          <p:nvPicPr>
            <p:cNvPr id="15" name="Grafik 14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2584" y="11161425"/>
              <a:ext cx="12613238" cy="4782765"/>
            </a:xfrm>
            <a:prstGeom prst="rect">
              <a:avLst/>
            </a:prstGeom>
          </p:spPr>
        </p:pic>
        <p:pic>
          <p:nvPicPr>
            <p:cNvPr id="16" name="Grafik 15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07160" y="11161425"/>
              <a:ext cx="12613238" cy="4782765"/>
            </a:xfrm>
            <a:prstGeom prst="rect">
              <a:avLst/>
            </a:prstGeom>
          </p:spPr>
        </p:pic>
        <p:pic>
          <p:nvPicPr>
            <p:cNvPr id="17" name="Grafik 16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07160" y="16019960"/>
              <a:ext cx="12613238" cy="4782765"/>
            </a:xfrm>
            <a:prstGeom prst="rect">
              <a:avLst/>
            </a:prstGeom>
          </p:spPr>
        </p:pic>
        <p:pic>
          <p:nvPicPr>
            <p:cNvPr id="18" name="Grafik 17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2584" y="16019960"/>
              <a:ext cx="12613238" cy="4782765"/>
            </a:xfrm>
            <a:prstGeom prst="rect">
              <a:avLst/>
            </a:prstGeom>
          </p:spPr>
        </p:pic>
        <p:pic>
          <p:nvPicPr>
            <p:cNvPr id="19" name="Grafik 18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807160" y="20878493"/>
              <a:ext cx="12613238" cy="4782765"/>
            </a:xfrm>
            <a:prstGeom prst="rect">
              <a:avLst/>
            </a:prstGeom>
          </p:spPr>
        </p:pic>
        <p:pic>
          <p:nvPicPr>
            <p:cNvPr id="20" name="Grafik 19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62584" y="20878493"/>
              <a:ext cx="12613238" cy="4782765"/>
            </a:xfrm>
            <a:prstGeom prst="rect">
              <a:avLst/>
            </a:prstGeom>
          </p:spPr>
        </p:pic>
      </p:grpSp>
      <p:sp>
        <p:nvSpPr>
          <p:cNvPr id="22" name="Rechteck 21"/>
          <p:cNvSpPr/>
          <p:nvPr/>
        </p:nvSpPr>
        <p:spPr>
          <a:xfrm>
            <a:off x="3146958" y="478804"/>
            <a:ext cx="12660202" cy="485442"/>
          </a:xfrm>
          <a:prstGeom prst="rect">
            <a:avLst/>
          </a:prstGeom>
          <a:solidFill>
            <a:srgbClr val="2F5597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800" b="1" dirty="0">
                <a:latin typeface="Arial" panose="020B0604020202020204" pitchFamily="34" charset="0"/>
                <a:cs typeface="Arial" panose="020B0604020202020204" pitchFamily="34" charset="0"/>
              </a:rPr>
              <a:t>LALDI</a:t>
            </a:r>
          </a:p>
        </p:txBody>
      </p:sp>
      <p:sp>
        <p:nvSpPr>
          <p:cNvPr id="23" name="Rechteck 22"/>
          <p:cNvSpPr/>
          <p:nvPr/>
        </p:nvSpPr>
        <p:spPr>
          <a:xfrm>
            <a:off x="16130454" y="476137"/>
            <a:ext cx="12660202" cy="485442"/>
          </a:xfrm>
          <a:prstGeom prst="rect">
            <a:avLst/>
          </a:prstGeom>
          <a:solidFill>
            <a:srgbClr val="C00000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2800" b="1" dirty="0">
                <a:latin typeface="Arial" panose="020B0604020202020204" pitchFamily="34" charset="0"/>
                <a:cs typeface="Arial" panose="020B0604020202020204" pitchFamily="34" charset="0"/>
              </a:rPr>
              <a:t>MALDI</a:t>
            </a:r>
          </a:p>
        </p:txBody>
      </p:sp>
    </p:spTree>
    <p:extLst>
      <p:ext uri="{BB962C8B-B14F-4D97-AF65-F5344CB8AC3E}">
        <p14:creationId xmlns:p14="http://schemas.microsoft.com/office/powerpoint/2010/main" val="11848029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74</Words>
  <Application>Microsoft Office PowerPoint</Application>
  <PresentationFormat>Custom</PresentationFormat>
  <Paragraphs>21</Paragraphs>
  <Slides>4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CS ChemDraw Drawing</vt:lpstr>
      <vt:lpstr>MestReNova.Document.1</vt:lpstr>
      <vt:lpstr>PowerPoint Presentation</vt:lpstr>
      <vt:lpstr>PowerPoint Presentation</vt:lpstr>
      <vt:lpstr>PowerPoint Presentation</vt:lpstr>
      <vt:lpstr>PowerPoint Pre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imu</dc:creator>
  <cp:lastModifiedBy>Lumada Luzviminda</cp:lastModifiedBy>
  <cp:revision>257</cp:revision>
  <dcterms:created xsi:type="dcterms:W3CDTF">2023-05-12T16:28:20Z</dcterms:created>
  <dcterms:modified xsi:type="dcterms:W3CDTF">2026-01-15T03:30:09Z</dcterms:modified>
</cp:coreProperties>
</file>